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83413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E0ABD5-DECC-49A7-A135-7EB995E0E7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D43E8-DDCC-406E-A7E0-AB3419E9C8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C4DF9-18F4-430C-AABA-D4C087788E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AE1C3B-5A44-4CFE-80B1-1164FE8489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D36E2-F3C6-4AC1-9233-3E122C54BE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A80B28-6EEF-47E2-AD9D-31511B4EB6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53221-FC53-40A0-9112-F6874D3CEB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AA1E3B-BC16-4243-8BFC-02692E331D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CEBF5-E207-4EE6-A344-4503EA8387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16ED7-BF33-4D50-B6C2-E2775032C8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F40FB2-5504-4974-9B13-414B949E71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E9768-3A70-44C0-B79A-1FD67E0B65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80E7473-ACA3-456A-94B2-C3703E3B7AA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57200" y="712800"/>
          <a:ext cx="5562720" cy="6684840"/>
        </p:xfrm>
        <a:graphic>
          <a:graphicData uri="http://schemas.openxmlformats.org/drawingml/2006/table">
            <a:tbl>
              <a:tblPr/>
              <a:tblGrid>
                <a:gridCol w="835200"/>
                <a:gridCol w="1110960"/>
                <a:gridCol w="1113120"/>
                <a:gridCol w="1252440"/>
                <a:gridCol w="1251000"/>
              </a:tblGrid>
              <a:tr h="183960">
                <a:tc gridSpan="4"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utely-infected monkeys (SHIV-SF162p3 for ~4 week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2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M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d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 (year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cropsy weight (kg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-1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-1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-2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6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3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0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9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61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gridSpan="4"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nically-infected monkeys (SIVmac251 for ~38 week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M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d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 (year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cropsy weight (kg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2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-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-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-1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-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-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-2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-1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-1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 gridSpan="4"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infected Healthy monkey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28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M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d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 (year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cropsy weight (kg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8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2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-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3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4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4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4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7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76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880">
                <a:tc gridSpan="4"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Uninfected monkeys with Chronic Enterocolitis (C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M I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d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 (year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cropsy weight (kg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 duration (months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43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-1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-0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396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-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ma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5"/>
          <p:cNvSpPr/>
          <p:nvPr/>
        </p:nvSpPr>
        <p:spPr>
          <a:xfrm>
            <a:off x="152280" y="15228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371520" y="446040"/>
            <a:ext cx="396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emographics of infected and uninfected rhesus macaques studi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Jacob</dc:creator>
  <dc:description/>
  <dc:language>en-US</dc:language>
  <cp:lastModifiedBy>Jacob Couturier</cp:lastModifiedBy>
  <cp:lastPrinted>2015-12-14T17:50:23Z</cp:lastPrinted>
  <dcterms:modified xsi:type="dcterms:W3CDTF">2016-04-06T03:47:50Z</dcterms:modified>
  <cp:revision>3972</cp:revision>
  <dc:subject/>
  <dc:title>Slide 1</dc:title>
</cp:coreProperties>
</file>